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53C91A-B3E6-4F5F-87FC-65BFE06753F6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848314-B607-4DF5-B374-3233003C69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38778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1848314-B607-4DF5-B374-3233003C6907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94750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2380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4264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219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650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3926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1071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8599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2961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2885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663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3853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5C09C-2821-4504-847B-493DAC8F710E}" type="datetimeFigureOut">
              <a:rPr lang="zh-CN" altLang="en-US" smtClean="0"/>
              <a:t>2025/7/10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4D409-E7B7-455A-8DB6-4486C6EE55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7721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tiff"/><Relationship Id="rId3" Type="http://schemas.openxmlformats.org/officeDocument/2006/relationships/image" Target="../media/image9.tiff"/><Relationship Id="rId7" Type="http://schemas.openxmlformats.org/officeDocument/2006/relationships/image" Target="../media/image13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f"/><Relationship Id="rId3" Type="http://schemas.openxmlformats.org/officeDocument/2006/relationships/image" Target="../media/image16.tiff"/><Relationship Id="rId7" Type="http://schemas.openxmlformats.org/officeDocument/2006/relationships/image" Target="../media/image20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tiff"/><Relationship Id="rId3" Type="http://schemas.openxmlformats.org/officeDocument/2006/relationships/image" Target="../media/image22.tiff"/><Relationship Id="rId7" Type="http://schemas.openxmlformats.org/officeDocument/2006/relationships/image" Target="../media/image26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tiff"/><Relationship Id="rId5" Type="http://schemas.openxmlformats.org/officeDocument/2006/relationships/image" Target="../media/image24.tiff"/><Relationship Id="rId4" Type="http://schemas.openxmlformats.org/officeDocument/2006/relationships/image" Target="../media/image23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tiff"/><Relationship Id="rId4" Type="http://schemas.openxmlformats.org/officeDocument/2006/relationships/image" Target="../media/image30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jpeg"/><Relationship Id="rId3" Type="http://schemas.openxmlformats.org/officeDocument/2006/relationships/image" Target="../media/image33.jpeg"/><Relationship Id="rId7" Type="http://schemas.openxmlformats.org/officeDocument/2006/relationships/image" Target="../media/image37.jpeg"/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jpeg"/><Relationship Id="rId5" Type="http://schemas.openxmlformats.org/officeDocument/2006/relationships/image" Target="../media/image35.jpeg"/><Relationship Id="rId10" Type="http://schemas.openxmlformats.org/officeDocument/2006/relationships/image" Target="../media/image31.tiff"/><Relationship Id="rId4" Type="http://schemas.openxmlformats.org/officeDocument/2006/relationships/image" Target="../media/image34.jpeg"/><Relationship Id="rId9" Type="http://schemas.openxmlformats.org/officeDocument/2006/relationships/image" Target="../media/image39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tiff"/><Relationship Id="rId7" Type="http://schemas.openxmlformats.org/officeDocument/2006/relationships/image" Target="../media/image45.tiff"/><Relationship Id="rId2" Type="http://schemas.openxmlformats.org/officeDocument/2006/relationships/image" Target="../media/image4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tiff"/><Relationship Id="rId5" Type="http://schemas.openxmlformats.org/officeDocument/2006/relationships/image" Target="../media/image43.tiff"/><Relationship Id="rId4" Type="http://schemas.openxmlformats.org/officeDocument/2006/relationships/image" Target="../media/image4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461247" y="1194081"/>
            <a:ext cx="9144000" cy="2387600"/>
          </a:xfrm>
        </p:spPr>
        <p:txBody>
          <a:bodyPr/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ull uncropped Gels and Blots image(s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461247" y="4453685"/>
            <a:ext cx="9144000" cy="485868"/>
          </a:xfrm>
        </p:spPr>
        <p:txBody>
          <a:bodyPr/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Veterinary Researc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64191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29988" y="105149"/>
            <a:ext cx="2571757" cy="744522"/>
          </a:xfrm>
        </p:spPr>
        <p:txBody>
          <a:bodyPr/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ure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组合 13"/>
          <p:cNvGrpSpPr/>
          <p:nvPr/>
        </p:nvGrpSpPr>
        <p:grpSpPr>
          <a:xfrm>
            <a:off x="5122836" y="866620"/>
            <a:ext cx="6619891" cy="1941309"/>
            <a:chOff x="5082818" y="1634798"/>
            <a:chExt cx="6619891" cy="1941309"/>
          </a:xfrm>
        </p:grpSpPr>
        <p:grpSp>
          <p:nvGrpSpPr>
            <p:cNvPr id="28" name="组合 27"/>
            <p:cNvGrpSpPr/>
            <p:nvPr/>
          </p:nvGrpSpPr>
          <p:grpSpPr>
            <a:xfrm>
              <a:off x="5082818" y="1666856"/>
              <a:ext cx="2175063" cy="1909251"/>
              <a:chOff x="4634191" y="760345"/>
              <a:chExt cx="2175063" cy="1909251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49041" y="1178917"/>
                <a:ext cx="1857948" cy="1490679"/>
              </a:xfrm>
              <a:prstGeom prst="rect">
                <a:avLst/>
              </a:prstGeom>
            </p:spPr>
          </p:pic>
          <p:sp>
            <p:nvSpPr>
              <p:cNvPr id="12" name="矩形 11"/>
              <p:cNvSpPr/>
              <p:nvPr/>
            </p:nvSpPr>
            <p:spPr>
              <a:xfrm>
                <a:off x="5066179" y="1782856"/>
                <a:ext cx="744071" cy="215153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>
                <a:off x="4634191" y="760345"/>
                <a:ext cx="21750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3B-DDX17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组合 28"/>
            <p:cNvGrpSpPr/>
            <p:nvPr/>
          </p:nvGrpSpPr>
          <p:grpSpPr>
            <a:xfrm>
              <a:off x="9527646" y="1653546"/>
              <a:ext cx="2175063" cy="1917128"/>
              <a:chOff x="9065214" y="752468"/>
              <a:chExt cx="2175063" cy="1917128"/>
            </a:xfrm>
          </p:grpSpPr>
          <p:pic>
            <p:nvPicPr>
              <p:cNvPr id="6" name="图片 5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139280" y="1178917"/>
                <a:ext cx="1857947" cy="1490679"/>
              </a:xfrm>
              <a:prstGeom prst="rect">
                <a:avLst/>
              </a:prstGeom>
            </p:spPr>
          </p:pic>
          <p:sp>
            <p:nvSpPr>
              <p:cNvPr id="17" name="矩形 16"/>
              <p:cNvSpPr/>
              <p:nvPr/>
            </p:nvSpPr>
            <p:spPr>
              <a:xfrm>
                <a:off x="9594833" y="1727033"/>
                <a:ext cx="744071" cy="215153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23"/>
              <p:cNvSpPr txBox="1"/>
              <p:nvPr/>
            </p:nvSpPr>
            <p:spPr>
              <a:xfrm>
                <a:off x="9065214" y="752468"/>
                <a:ext cx="21750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3B-GAPDH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" name="组合 29"/>
            <p:cNvGrpSpPr/>
            <p:nvPr/>
          </p:nvGrpSpPr>
          <p:grpSpPr>
            <a:xfrm>
              <a:off x="7357302" y="1634798"/>
              <a:ext cx="2175063" cy="1935876"/>
              <a:chOff x="5804895" y="4934464"/>
              <a:chExt cx="2175063" cy="1935876"/>
            </a:xfrm>
          </p:grpSpPr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10250" y="5379661"/>
                <a:ext cx="1857948" cy="1490679"/>
              </a:xfrm>
              <a:prstGeom prst="rect">
                <a:avLst/>
              </a:prstGeom>
            </p:spPr>
          </p:pic>
          <p:sp>
            <p:nvSpPr>
              <p:cNvPr id="18" name="矩形 17"/>
              <p:cNvSpPr/>
              <p:nvPr/>
            </p:nvSpPr>
            <p:spPr>
              <a:xfrm>
                <a:off x="6210892" y="6077756"/>
                <a:ext cx="828053" cy="215153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/>
              <p:cNvSpPr txBox="1"/>
              <p:nvPr/>
            </p:nvSpPr>
            <p:spPr>
              <a:xfrm>
                <a:off x="5804895" y="4934464"/>
                <a:ext cx="21750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3B-C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2" name="组合 41"/>
          <p:cNvGrpSpPr/>
          <p:nvPr/>
        </p:nvGrpSpPr>
        <p:grpSpPr>
          <a:xfrm>
            <a:off x="5122836" y="3500591"/>
            <a:ext cx="6756455" cy="2083993"/>
            <a:chOff x="5084342" y="3260605"/>
            <a:chExt cx="6756455" cy="2083993"/>
          </a:xfrm>
        </p:grpSpPr>
        <p:grpSp>
          <p:nvGrpSpPr>
            <p:cNvPr id="41" name="组合 40"/>
            <p:cNvGrpSpPr/>
            <p:nvPr/>
          </p:nvGrpSpPr>
          <p:grpSpPr>
            <a:xfrm>
              <a:off x="5084342" y="3260605"/>
              <a:ext cx="2274742" cy="2083993"/>
              <a:chOff x="5084342" y="3260605"/>
              <a:chExt cx="2274742" cy="2083993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84342" y="3662102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19" name="矩形 18"/>
              <p:cNvSpPr/>
              <p:nvPr/>
            </p:nvSpPr>
            <p:spPr>
              <a:xfrm>
                <a:off x="5529025" y="4095764"/>
                <a:ext cx="1248207" cy="215153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/>
              <p:cNvSpPr txBox="1"/>
              <p:nvPr/>
            </p:nvSpPr>
            <p:spPr>
              <a:xfrm>
                <a:off x="5184021" y="3260605"/>
                <a:ext cx="21750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3D-DDX17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0" name="组合 39"/>
            <p:cNvGrpSpPr/>
            <p:nvPr/>
          </p:nvGrpSpPr>
          <p:grpSpPr>
            <a:xfrm>
              <a:off x="7384270" y="3263507"/>
              <a:ext cx="2459183" cy="2080835"/>
              <a:chOff x="7384270" y="3263507"/>
              <a:chExt cx="2459183" cy="2080835"/>
            </a:xfrm>
          </p:grpSpPr>
          <p:pic>
            <p:nvPicPr>
              <p:cNvPr id="13" name="图片 12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84270" y="3661846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20" name="矩形 19"/>
              <p:cNvSpPr/>
              <p:nvPr/>
            </p:nvSpPr>
            <p:spPr>
              <a:xfrm>
                <a:off x="7972220" y="4254472"/>
                <a:ext cx="1202069" cy="215153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/>
              <p:cNvSpPr txBox="1"/>
              <p:nvPr/>
            </p:nvSpPr>
            <p:spPr>
              <a:xfrm>
                <a:off x="7668390" y="3263507"/>
                <a:ext cx="21750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3D-C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" name="组合 38"/>
            <p:cNvGrpSpPr/>
            <p:nvPr/>
          </p:nvGrpSpPr>
          <p:grpSpPr>
            <a:xfrm>
              <a:off x="9665734" y="3260605"/>
              <a:ext cx="2175063" cy="2083737"/>
              <a:chOff x="9665734" y="3260605"/>
              <a:chExt cx="2175063" cy="2083737"/>
            </a:xfrm>
          </p:grpSpPr>
          <p:pic>
            <p:nvPicPr>
              <p:cNvPr id="38" name="图片 37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704754" y="3661846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21" name="矩形 20"/>
              <p:cNvSpPr/>
              <p:nvPr/>
            </p:nvSpPr>
            <p:spPr>
              <a:xfrm>
                <a:off x="10073637" y="4131699"/>
                <a:ext cx="1247902" cy="221995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/>
              <p:cNvSpPr txBox="1"/>
              <p:nvPr/>
            </p:nvSpPr>
            <p:spPr>
              <a:xfrm>
                <a:off x="9665734" y="3260605"/>
                <a:ext cx="21750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3D-GAPDH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4" name="组合 43"/>
          <p:cNvGrpSpPr/>
          <p:nvPr/>
        </p:nvGrpSpPr>
        <p:grpSpPr>
          <a:xfrm>
            <a:off x="217936" y="975767"/>
            <a:ext cx="4678565" cy="5667349"/>
            <a:chOff x="217936" y="975767"/>
            <a:chExt cx="4678565" cy="5667349"/>
          </a:xfrm>
        </p:grpSpPr>
        <p:pic>
          <p:nvPicPr>
            <p:cNvPr id="37" name="图片 36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7936" y="1129284"/>
              <a:ext cx="4462272" cy="5513832"/>
            </a:xfrm>
            <a:prstGeom prst="rect">
              <a:avLst/>
            </a:prstGeom>
          </p:spPr>
        </p:pic>
        <p:sp>
          <p:nvSpPr>
            <p:cNvPr id="43" name="矩形 42"/>
            <p:cNvSpPr/>
            <p:nvPr/>
          </p:nvSpPr>
          <p:spPr>
            <a:xfrm>
              <a:off x="2580456" y="975767"/>
              <a:ext cx="2316045" cy="328246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253068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046" y="116542"/>
            <a:ext cx="3384178" cy="762000"/>
          </a:xfrm>
        </p:spPr>
        <p:txBody>
          <a:bodyPr>
            <a:normAutofit fontScale="90000"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-B, 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组合 27"/>
          <p:cNvGrpSpPr/>
          <p:nvPr/>
        </p:nvGrpSpPr>
        <p:grpSpPr>
          <a:xfrm>
            <a:off x="5002128" y="4211948"/>
            <a:ext cx="6778846" cy="2068224"/>
            <a:chOff x="5088940" y="3800271"/>
            <a:chExt cx="6778846" cy="2068224"/>
          </a:xfrm>
        </p:grpSpPr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05249" y="4185999"/>
              <a:ext cx="2097024" cy="1682496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92723" y="4185999"/>
              <a:ext cx="2097024" cy="1682496"/>
            </a:xfrm>
            <a:prstGeom prst="rect">
              <a:avLst/>
            </a:prstGeom>
          </p:spPr>
        </p:pic>
        <p:grpSp>
          <p:nvGrpSpPr>
            <p:cNvPr id="19" name="组合 18"/>
            <p:cNvGrpSpPr/>
            <p:nvPr/>
          </p:nvGrpSpPr>
          <p:grpSpPr>
            <a:xfrm>
              <a:off x="7467267" y="3800271"/>
              <a:ext cx="2175063" cy="1478741"/>
              <a:chOff x="7648300" y="4187066"/>
              <a:chExt cx="2175063" cy="1478741"/>
            </a:xfrm>
          </p:grpSpPr>
          <p:sp>
            <p:nvSpPr>
              <p:cNvPr id="12" name="矩形 11"/>
              <p:cNvSpPr/>
              <p:nvPr/>
            </p:nvSpPr>
            <p:spPr>
              <a:xfrm>
                <a:off x="7898777" y="5450654"/>
                <a:ext cx="1411942" cy="215153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7648300" y="4187066"/>
                <a:ext cx="21750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4D-DDX17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组合 19"/>
            <p:cNvGrpSpPr/>
            <p:nvPr/>
          </p:nvGrpSpPr>
          <p:grpSpPr>
            <a:xfrm>
              <a:off x="9692723" y="3816667"/>
              <a:ext cx="2175063" cy="1101105"/>
              <a:chOff x="9873756" y="4203462"/>
              <a:chExt cx="2175063" cy="1101105"/>
            </a:xfrm>
          </p:grpSpPr>
          <p:sp>
            <p:nvSpPr>
              <p:cNvPr id="14" name="矩形 13"/>
              <p:cNvSpPr/>
              <p:nvPr/>
            </p:nvSpPr>
            <p:spPr>
              <a:xfrm>
                <a:off x="10196991" y="5089414"/>
                <a:ext cx="1411942" cy="215153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/>
              <p:cNvSpPr txBox="1"/>
              <p:nvPr/>
            </p:nvSpPr>
            <p:spPr>
              <a:xfrm>
                <a:off x="9873756" y="4203462"/>
                <a:ext cx="21750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4D-GAPDH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" name="组合 26"/>
            <p:cNvGrpSpPr/>
            <p:nvPr/>
          </p:nvGrpSpPr>
          <p:grpSpPr>
            <a:xfrm>
              <a:off x="5088940" y="3824711"/>
              <a:ext cx="2484680" cy="2043784"/>
              <a:chOff x="5273534" y="3824710"/>
              <a:chExt cx="2484680" cy="2043784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273534" y="4185998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23" name="矩形 22"/>
              <p:cNvSpPr/>
              <p:nvPr/>
            </p:nvSpPr>
            <p:spPr>
              <a:xfrm>
                <a:off x="5616913" y="4805339"/>
                <a:ext cx="1426489" cy="22486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5583151" y="3824710"/>
                <a:ext cx="21750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4D-C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4" name="组合 33"/>
          <p:cNvGrpSpPr/>
          <p:nvPr/>
        </p:nvGrpSpPr>
        <p:grpSpPr>
          <a:xfrm>
            <a:off x="5206768" y="439034"/>
            <a:ext cx="6644931" cy="3273074"/>
            <a:chOff x="5206768" y="439034"/>
            <a:chExt cx="6644931" cy="3273074"/>
          </a:xfrm>
        </p:grpSpPr>
        <p:pic>
          <p:nvPicPr>
            <p:cNvPr id="33" name="图片 3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04595" y="439034"/>
              <a:ext cx="6547104" cy="3267456"/>
            </a:xfrm>
            <a:prstGeom prst="rect">
              <a:avLst/>
            </a:prstGeom>
          </p:spPr>
        </p:pic>
        <p:sp>
          <p:nvSpPr>
            <p:cNvPr id="31" name="矩形 30"/>
            <p:cNvSpPr/>
            <p:nvPr/>
          </p:nvSpPr>
          <p:spPr>
            <a:xfrm>
              <a:off x="5206768" y="2283151"/>
              <a:ext cx="3587608" cy="142895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组合 45"/>
          <p:cNvGrpSpPr/>
          <p:nvPr/>
        </p:nvGrpSpPr>
        <p:grpSpPr>
          <a:xfrm>
            <a:off x="215207" y="1305039"/>
            <a:ext cx="4332822" cy="4377170"/>
            <a:chOff x="323088" y="1654662"/>
            <a:chExt cx="4332822" cy="4377170"/>
          </a:xfrm>
        </p:grpSpPr>
        <p:grpSp>
          <p:nvGrpSpPr>
            <p:cNvPr id="45" name="组合 44"/>
            <p:cNvGrpSpPr/>
            <p:nvPr/>
          </p:nvGrpSpPr>
          <p:grpSpPr>
            <a:xfrm>
              <a:off x="323088" y="1654662"/>
              <a:ext cx="2097024" cy="2051828"/>
              <a:chOff x="323088" y="1654662"/>
              <a:chExt cx="2097024" cy="2051828"/>
            </a:xfrm>
          </p:grpSpPr>
          <p:pic>
            <p:nvPicPr>
              <p:cNvPr id="36" name="图片 35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3088" y="2023994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37" name="矩形 36"/>
              <p:cNvSpPr/>
              <p:nvPr/>
            </p:nvSpPr>
            <p:spPr>
              <a:xfrm>
                <a:off x="555809" y="2629511"/>
                <a:ext cx="430310" cy="22486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455353" y="1654662"/>
                <a:ext cx="17230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</a:t>
                </a:r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B-C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4" name="组合 43"/>
            <p:cNvGrpSpPr/>
            <p:nvPr/>
          </p:nvGrpSpPr>
          <p:grpSpPr>
            <a:xfrm>
              <a:off x="2558886" y="1664440"/>
              <a:ext cx="2097024" cy="2042050"/>
              <a:chOff x="2558886" y="1664440"/>
              <a:chExt cx="2097024" cy="2042050"/>
            </a:xfrm>
          </p:grpSpPr>
          <p:pic>
            <p:nvPicPr>
              <p:cNvPr id="35" name="图片 34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58886" y="2023994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38" name="矩形 37"/>
              <p:cNvSpPr/>
              <p:nvPr/>
            </p:nvSpPr>
            <p:spPr>
              <a:xfrm>
                <a:off x="2791675" y="2539861"/>
                <a:ext cx="430310" cy="22486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2817391" y="1664440"/>
                <a:ext cx="172307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</a:t>
                </a:r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B-Flag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3" name="组合 42"/>
            <p:cNvGrpSpPr/>
            <p:nvPr/>
          </p:nvGrpSpPr>
          <p:grpSpPr>
            <a:xfrm>
              <a:off x="1581903" y="4001018"/>
              <a:ext cx="2448007" cy="2030814"/>
              <a:chOff x="1581903" y="4001018"/>
              <a:chExt cx="2448007" cy="2030814"/>
            </a:xfrm>
          </p:grpSpPr>
          <p:pic>
            <p:nvPicPr>
              <p:cNvPr id="32" name="图片 31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81903" y="4349336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39" name="矩形 38"/>
              <p:cNvSpPr/>
              <p:nvPr/>
            </p:nvSpPr>
            <p:spPr>
              <a:xfrm>
                <a:off x="1810867" y="4878837"/>
                <a:ext cx="430310" cy="22486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文本框 41"/>
              <p:cNvSpPr txBox="1"/>
              <p:nvPr/>
            </p:nvSpPr>
            <p:spPr>
              <a:xfrm>
                <a:off x="1581903" y="4001018"/>
                <a:ext cx="244800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</a:t>
                </a:r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B-β-acting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356098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046" y="116542"/>
            <a:ext cx="10515600" cy="762000"/>
          </a:xfrm>
        </p:spPr>
        <p:txBody>
          <a:bodyPr/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4-F, H</a:t>
            </a:r>
            <a:endParaRPr lang="zh-CN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组合 27"/>
          <p:cNvGrpSpPr/>
          <p:nvPr/>
        </p:nvGrpSpPr>
        <p:grpSpPr>
          <a:xfrm>
            <a:off x="357247" y="1604170"/>
            <a:ext cx="4666806" cy="4305820"/>
            <a:chOff x="252344" y="1240550"/>
            <a:chExt cx="4739320" cy="4473974"/>
          </a:xfrm>
        </p:grpSpPr>
        <p:grpSp>
          <p:nvGrpSpPr>
            <p:cNvPr id="27" name="组合 26"/>
            <p:cNvGrpSpPr/>
            <p:nvPr/>
          </p:nvGrpSpPr>
          <p:grpSpPr>
            <a:xfrm>
              <a:off x="252344" y="1240550"/>
              <a:ext cx="2496459" cy="2042759"/>
              <a:chOff x="1713591" y="3800153"/>
              <a:chExt cx="2496459" cy="2042759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13591" y="4160416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21" name="矩形 20"/>
              <p:cNvSpPr/>
              <p:nvPr/>
            </p:nvSpPr>
            <p:spPr>
              <a:xfrm>
                <a:off x="2484197" y="5100276"/>
                <a:ext cx="555811" cy="215153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>
                <a:off x="2034987" y="3800153"/>
                <a:ext cx="2175063" cy="38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4F-C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" name="组合 17"/>
            <p:cNvGrpSpPr/>
            <p:nvPr/>
          </p:nvGrpSpPr>
          <p:grpSpPr>
            <a:xfrm>
              <a:off x="2748803" y="1240550"/>
              <a:ext cx="2242861" cy="2051828"/>
              <a:chOff x="3863405" y="3791084"/>
              <a:chExt cx="2242861" cy="2051828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63405" y="4160416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23" name="矩形 22"/>
              <p:cNvSpPr/>
              <p:nvPr/>
            </p:nvSpPr>
            <p:spPr>
              <a:xfrm>
                <a:off x="4625788" y="4986858"/>
                <a:ext cx="555811" cy="215153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/>
              <p:cNvSpPr txBox="1"/>
              <p:nvPr/>
            </p:nvSpPr>
            <p:spPr>
              <a:xfrm>
                <a:off x="3931203" y="3791084"/>
                <a:ext cx="2175063" cy="38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4F-DDX17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/>
            <p:cNvGrpSpPr/>
            <p:nvPr/>
          </p:nvGrpSpPr>
          <p:grpSpPr>
            <a:xfrm>
              <a:off x="1300855" y="3661710"/>
              <a:ext cx="2161835" cy="2052814"/>
              <a:chOff x="6013219" y="3790098"/>
              <a:chExt cx="2161835" cy="2052814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13219" y="4160416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24" name="矩形 23"/>
              <p:cNvSpPr/>
              <p:nvPr/>
            </p:nvSpPr>
            <p:spPr>
              <a:xfrm>
                <a:off x="6783825" y="4678902"/>
                <a:ext cx="555811" cy="215153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/>
              <p:cNvSpPr txBox="1"/>
              <p:nvPr/>
            </p:nvSpPr>
            <p:spPr>
              <a:xfrm>
                <a:off x="6081017" y="3790098"/>
                <a:ext cx="2094037" cy="383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4F-GAPDH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0" name="组合 19"/>
          <p:cNvGrpSpPr/>
          <p:nvPr/>
        </p:nvGrpSpPr>
        <p:grpSpPr>
          <a:xfrm>
            <a:off x="5210822" y="4049328"/>
            <a:ext cx="6568557" cy="2102063"/>
            <a:chOff x="5076352" y="3873455"/>
            <a:chExt cx="6568557" cy="2102063"/>
          </a:xfrm>
        </p:grpSpPr>
        <p:grpSp>
          <p:nvGrpSpPr>
            <p:cNvPr id="15" name="组合 14"/>
            <p:cNvGrpSpPr/>
            <p:nvPr/>
          </p:nvGrpSpPr>
          <p:grpSpPr>
            <a:xfrm>
              <a:off x="5076352" y="3897427"/>
              <a:ext cx="2407692" cy="2078091"/>
              <a:chOff x="5076352" y="3897427"/>
              <a:chExt cx="2407692" cy="2078091"/>
            </a:xfrm>
          </p:grpSpPr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76352" y="4293022"/>
                <a:ext cx="2097024" cy="1682496"/>
              </a:xfrm>
              <a:prstGeom prst="rect">
                <a:avLst/>
              </a:prstGeom>
            </p:spPr>
          </p:pic>
          <p:grpSp>
            <p:nvGrpSpPr>
              <p:cNvPr id="38" name="组合 37"/>
              <p:cNvGrpSpPr/>
              <p:nvPr/>
            </p:nvGrpSpPr>
            <p:grpSpPr>
              <a:xfrm>
                <a:off x="5342260" y="3897427"/>
                <a:ext cx="2141784" cy="1587581"/>
                <a:chOff x="5806106" y="3809171"/>
                <a:chExt cx="2141784" cy="1587581"/>
              </a:xfrm>
            </p:grpSpPr>
            <p:sp>
              <p:nvSpPr>
                <p:cNvPr id="32" name="矩形 31"/>
                <p:cNvSpPr/>
                <p:nvPr/>
              </p:nvSpPr>
              <p:spPr>
                <a:xfrm>
                  <a:off x="6041403" y="5186011"/>
                  <a:ext cx="682126" cy="210741"/>
                </a:xfrm>
                <a:prstGeom prst="rect">
                  <a:avLst/>
                </a:prstGeom>
                <a:noFill/>
                <a:ln w="28575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文本框 34"/>
                <p:cNvSpPr txBox="1"/>
                <p:nvPr/>
              </p:nvSpPr>
              <p:spPr>
                <a:xfrm>
                  <a:off x="5806106" y="3809171"/>
                  <a:ext cx="214178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igure 4H-C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6" name="组合 15"/>
            <p:cNvGrpSpPr/>
            <p:nvPr/>
          </p:nvGrpSpPr>
          <p:grpSpPr>
            <a:xfrm>
              <a:off x="7246194" y="3897427"/>
              <a:ext cx="2256931" cy="2075905"/>
              <a:chOff x="7246194" y="3897427"/>
              <a:chExt cx="2256931" cy="2075905"/>
            </a:xfrm>
          </p:grpSpPr>
          <p:pic>
            <p:nvPicPr>
              <p:cNvPr id="10" name="图片 9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246194" y="4290836"/>
                <a:ext cx="2097024" cy="1682496"/>
              </a:xfrm>
              <a:prstGeom prst="rect">
                <a:avLst/>
              </a:prstGeom>
            </p:spPr>
          </p:pic>
          <p:grpSp>
            <p:nvGrpSpPr>
              <p:cNvPr id="39" name="组合 38"/>
              <p:cNvGrpSpPr/>
              <p:nvPr/>
            </p:nvGrpSpPr>
            <p:grpSpPr>
              <a:xfrm>
                <a:off x="7361341" y="3897427"/>
                <a:ext cx="2141784" cy="1442537"/>
                <a:chOff x="7963000" y="3848844"/>
                <a:chExt cx="2141784" cy="1442537"/>
              </a:xfrm>
            </p:grpSpPr>
            <p:sp>
              <p:nvSpPr>
                <p:cNvPr id="33" name="矩形 32"/>
                <p:cNvSpPr/>
                <p:nvPr/>
              </p:nvSpPr>
              <p:spPr>
                <a:xfrm>
                  <a:off x="8583419" y="5080640"/>
                  <a:ext cx="682126" cy="210741"/>
                </a:xfrm>
                <a:prstGeom prst="rect">
                  <a:avLst/>
                </a:prstGeom>
                <a:noFill/>
                <a:ln w="28575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文本框 35"/>
                <p:cNvSpPr txBox="1"/>
                <p:nvPr/>
              </p:nvSpPr>
              <p:spPr>
                <a:xfrm>
                  <a:off x="7963000" y="3848844"/>
                  <a:ext cx="214178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igure 4H-DDX17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19" name="组合 18"/>
            <p:cNvGrpSpPr/>
            <p:nvPr/>
          </p:nvGrpSpPr>
          <p:grpSpPr>
            <a:xfrm>
              <a:off x="9416036" y="3873455"/>
              <a:ext cx="2228873" cy="2099772"/>
              <a:chOff x="9416036" y="3873455"/>
              <a:chExt cx="2228873" cy="2099772"/>
            </a:xfrm>
          </p:grpSpPr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416036" y="4290731"/>
                <a:ext cx="2097024" cy="1682496"/>
              </a:xfrm>
              <a:prstGeom prst="rect">
                <a:avLst/>
              </a:prstGeom>
            </p:spPr>
          </p:pic>
          <p:grpSp>
            <p:nvGrpSpPr>
              <p:cNvPr id="40" name="组合 39"/>
              <p:cNvGrpSpPr/>
              <p:nvPr/>
            </p:nvGrpSpPr>
            <p:grpSpPr>
              <a:xfrm>
                <a:off x="9503125" y="3873455"/>
                <a:ext cx="2141784" cy="1230548"/>
                <a:chOff x="9836373" y="3715267"/>
                <a:chExt cx="2141784" cy="1230548"/>
              </a:xfrm>
            </p:grpSpPr>
            <p:sp>
              <p:nvSpPr>
                <p:cNvPr id="34" name="矩形 33"/>
                <p:cNvSpPr/>
                <p:nvPr/>
              </p:nvSpPr>
              <p:spPr>
                <a:xfrm>
                  <a:off x="10438803" y="4735074"/>
                  <a:ext cx="682126" cy="210741"/>
                </a:xfrm>
                <a:prstGeom prst="rect">
                  <a:avLst/>
                </a:prstGeom>
                <a:noFill/>
                <a:ln w="28575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文本框 36"/>
                <p:cNvSpPr txBox="1"/>
                <p:nvPr/>
              </p:nvSpPr>
              <p:spPr>
                <a:xfrm>
                  <a:off x="9836373" y="3715267"/>
                  <a:ext cx="214178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igure 4H-GAPDH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grpSp>
        <p:nvGrpSpPr>
          <p:cNvPr id="49" name="组合 48"/>
          <p:cNvGrpSpPr/>
          <p:nvPr/>
        </p:nvGrpSpPr>
        <p:grpSpPr>
          <a:xfrm>
            <a:off x="5476730" y="291250"/>
            <a:ext cx="6547104" cy="3267456"/>
            <a:chOff x="5476730" y="291250"/>
            <a:chExt cx="6547104" cy="3267456"/>
          </a:xfrm>
        </p:grpSpPr>
        <p:pic>
          <p:nvPicPr>
            <p:cNvPr id="47" name="图片 46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76730" y="291250"/>
              <a:ext cx="6547104" cy="3267456"/>
            </a:xfrm>
            <a:prstGeom prst="rect">
              <a:avLst/>
            </a:prstGeom>
          </p:spPr>
        </p:pic>
        <p:sp>
          <p:nvSpPr>
            <p:cNvPr id="48" name="矩形 47"/>
            <p:cNvSpPr/>
            <p:nvPr/>
          </p:nvSpPr>
          <p:spPr>
            <a:xfrm>
              <a:off x="8967218" y="2129749"/>
              <a:ext cx="3056616" cy="142895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198081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标题 1"/>
          <p:cNvSpPr>
            <a:spLocks noGrp="1"/>
          </p:cNvSpPr>
          <p:nvPr>
            <p:ph type="title"/>
          </p:nvPr>
        </p:nvSpPr>
        <p:spPr>
          <a:xfrm>
            <a:off x="623046" y="116542"/>
            <a:ext cx="2380130" cy="762000"/>
          </a:xfrm>
        </p:spPr>
        <p:txBody>
          <a:bodyPr/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ure 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5583567" y="1362914"/>
            <a:ext cx="6673960" cy="2051828"/>
            <a:chOff x="5608960" y="625515"/>
            <a:chExt cx="6673960" cy="2051828"/>
          </a:xfrm>
        </p:grpSpPr>
        <p:grpSp>
          <p:nvGrpSpPr>
            <p:cNvPr id="24" name="组合 23"/>
            <p:cNvGrpSpPr/>
            <p:nvPr/>
          </p:nvGrpSpPr>
          <p:grpSpPr>
            <a:xfrm>
              <a:off x="5608960" y="626353"/>
              <a:ext cx="2097024" cy="2050990"/>
              <a:chOff x="5608960" y="626353"/>
              <a:chExt cx="2097024" cy="2050990"/>
            </a:xfrm>
          </p:grpSpPr>
          <p:pic>
            <p:nvPicPr>
              <p:cNvPr id="6" name="图片 5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08960" y="994847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12" name="矩形 11"/>
              <p:cNvSpPr/>
              <p:nvPr/>
            </p:nvSpPr>
            <p:spPr>
              <a:xfrm>
                <a:off x="6678707" y="1625355"/>
                <a:ext cx="636494" cy="22137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/>
              <p:cNvSpPr txBox="1"/>
              <p:nvPr/>
            </p:nvSpPr>
            <p:spPr>
              <a:xfrm>
                <a:off x="5883478" y="626353"/>
                <a:ext cx="161998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5D-C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5" name="组合 24"/>
            <p:cNvGrpSpPr/>
            <p:nvPr/>
          </p:nvGrpSpPr>
          <p:grpSpPr>
            <a:xfrm>
              <a:off x="7779138" y="625515"/>
              <a:ext cx="2097024" cy="2051828"/>
              <a:chOff x="7779138" y="625515"/>
              <a:chExt cx="2097024" cy="2051828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79138" y="994847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14" name="文本框 13"/>
              <p:cNvSpPr txBox="1"/>
              <p:nvPr/>
            </p:nvSpPr>
            <p:spPr>
              <a:xfrm>
                <a:off x="7980502" y="625515"/>
                <a:ext cx="18956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5D-Flag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矩形 15"/>
              <p:cNvSpPr/>
              <p:nvPr/>
            </p:nvSpPr>
            <p:spPr>
              <a:xfrm>
                <a:off x="8827651" y="1472267"/>
                <a:ext cx="621150" cy="304501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组合 25"/>
            <p:cNvGrpSpPr/>
            <p:nvPr/>
          </p:nvGrpSpPr>
          <p:grpSpPr>
            <a:xfrm>
              <a:off x="9940330" y="625515"/>
              <a:ext cx="2342590" cy="2051828"/>
              <a:chOff x="9940330" y="625515"/>
              <a:chExt cx="2342590" cy="2051828"/>
            </a:xfrm>
          </p:grpSpPr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940330" y="994847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15" name="文本框 14"/>
              <p:cNvSpPr txBox="1"/>
              <p:nvPr/>
            </p:nvSpPr>
            <p:spPr>
              <a:xfrm>
                <a:off x="9980986" y="625515"/>
                <a:ext cx="230193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5D-β-acting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矩形 16"/>
              <p:cNvSpPr/>
              <p:nvPr/>
            </p:nvSpPr>
            <p:spPr>
              <a:xfrm>
                <a:off x="10979876" y="1537078"/>
                <a:ext cx="638383" cy="239689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2" name="组合 31"/>
          <p:cNvGrpSpPr/>
          <p:nvPr/>
        </p:nvGrpSpPr>
        <p:grpSpPr>
          <a:xfrm>
            <a:off x="5583567" y="4519301"/>
            <a:ext cx="6440321" cy="2051828"/>
            <a:chOff x="5601008" y="3500561"/>
            <a:chExt cx="6440321" cy="2051828"/>
          </a:xfrm>
        </p:grpSpPr>
        <p:grpSp>
          <p:nvGrpSpPr>
            <p:cNvPr id="28" name="组合 27"/>
            <p:cNvGrpSpPr/>
            <p:nvPr/>
          </p:nvGrpSpPr>
          <p:grpSpPr>
            <a:xfrm>
              <a:off x="9926864" y="3500561"/>
              <a:ext cx="2114465" cy="2051828"/>
              <a:chOff x="5721075" y="3567352"/>
              <a:chExt cx="2114465" cy="2051828"/>
            </a:xfrm>
          </p:grpSpPr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21075" y="3936684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18" name="文本框 17"/>
              <p:cNvSpPr txBox="1"/>
              <p:nvPr/>
            </p:nvSpPr>
            <p:spPr>
              <a:xfrm>
                <a:off x="5777115" y="3567352"/>
                <a:ext cx="20584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5F-β-acting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矩形 20"/>
              <p:cNvSpPr/>
              <p:nvPr/>
            </p:nvSpPr>
            <p:spPr>
              <a:xfrm>
                <a:off x="6769588" y="4556558"/>
                <a:ext cx="569653" cy="22137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组合 28"/>
            <p:cNvGrpSpPr/>
            <p:nvPr/>
          </p:nvGrpSpPr>
          <p:grpSpPr>
            <a:xfrm>
              <a:off x="7774676" y="3500561"/>
              <a:ext cx="2097024" cy="2051828"/>
              <a:chOff x="7883962" y="3567352"/>
              <a:chExt cx="2097024" cy="2051828"/>
            </a:xfrm>
          </p:grpSpPr>
          <p:pic>
            <p:nvPicPr>
              <p:cNvPr id="10" name="图片 9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883962" y="3936684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19" name="文本框 18"/>
              <p:cNvSpPr txBox="1"/>
              <p:nvPr/>
            </p:nvSpPr>
            <p:spPr>
              <a:xfrm>
                <a:off x="8024810" y="3567352"/>
                <a:ext cx="18956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5F-Flag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矩形 21"/>
              <p:cNvSpPr/>
              <p:nvPr/>
            </p:nvSpPr>
            <p:spPr>
              <a:xfrm>
                <a:off x="8972640" y="4556558"/>
                <a:ext cx="569653" cy="22137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" name="组合 29"/>
            <p:cNvGrpSpPr/>
            <p:nvPr/>
          </p:nvGrpSpPr>
          <p:grpSpPr>
            <a:xfrm>
              <a:off x="5601008" y="3504887"/>
              <a:ext cx="2164664" cy="2047502"/>
              <a:chOff x="10030808" y="3571678"/>
              <a:chExt cx="2164664" cy="2047502"/>
            </a:xfrm>
          </p:grpSpPr>
          <p:pic>
            <p:nvPicPr>
              <p:cNvPr id="9" name="图片 8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030808" y="3936684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20" name="文本框 19"/>
              <p:cNvSpPr txBox="1"/>
              <p:nvPr/>
            </p:nvSpPr>
            <p:spPr>
              <a:xfrm>
                <a:off x="10300973" y="3571678"/>
                <a:ext cx="189449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5F-C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矩形 22"/>
              <p:cNvSpPr/>
              <p:nvPr/>
            </p:nvSpPr>
            <p:spPr>
              <a:xfrm>
                <a:off x="11135625" y="4445871"/>
                <a:ext cx="569653" cy="22137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" name="组合 1"/>
          <p:cNvGrpSpPr/>
          <p:nvPr/>
        </p:nvGrpSpPr>
        <p:grpSpPr>
          <a:xfrm>
            <a:off x="10937" y="1039906"/>
            <a:ext cx="5363938" cy="5621340"/>
            <a:chOff x="10936" y="959223"/>
            <a:chExt cx="5572631" cy="5702023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936" y="959223"/>
              <a:ext cx="5517029" cy="5702023"/>
            </a:xfrm>
            <a:prstGeom prst="rect">
              <a:avLst/>
            </a:prstGeom>
          </p:spPr>
        </p:pic>
        <p:sp>
          <p:nvSpPr>
            <p:cNvPr id="31" name="矩形 30"/>
            <p:cNvSpPr/>
            <p:nvPr/>
          </p:nvSpPr>
          <p:spPr>
            <a:xfrm>
              <a:off x="3883227" y="2104295"/>
              <a:ext cx="1700340" cy="1526411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矩形 32"/>
            <p:cNvSpPr/>
            <p:nvPr/>
          </p:nvSpPr>
          <p:spPr>
            <a:xfrm>
              <a:off x="10936" y="4824572"/>
              <a:ext cx="1539958" cy="174655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4259582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标题 1"/>
          <p:cNvSpPr>
            <a:spLocks noGrp="1"/>
          </p:cNvSpPr>
          <p:nvPr>
            <p:ph type="title"/>
          </p:nvPr>
        </p:nvSpPr>
        <p:spPr>
          <a:xfrm>
            <a:off x="623046" y="58898"/>
            <a:ext cx="3231778" cy="762000"/>
          </a:xfrm>
        </p:spPr>
        <p:txBody>
          <a:bodyPr>
            <a:norm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6-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组合 25"/>
          <p:cNvGrpSpPr/>
          <p:nvPr/>
        </p:nvGrpSpPr>
        <p:grpSpPr>
          <a:xfrm>
            <a:off x="6953218" y="1177062"/>
            <a:ext cx="4586194" cy="4474068"/>
            <a:chOff x="7105618" y="1302568"/>
            <a:chExt cx="4586194" cy="4474068"/>
          </a:xfrm>
        </p:grpSpPr>
        <p:grpSp>
          <p:nvGrpSpPr>
            <p:cNvPr id="21" name="组合 20"/>
            <p:cNvGrpSpPr/>
            <p:nvPr/>
          </p:nvGrpSpPr>
          <p:grpSpPr>
            <a:xfrm>
              <a:off x="7105618" y="1303108"/>
              <a:ext cx="2097024" cy="2051828"/>
              <a:chOff x="7105618" y="1303108"/>
              <a:chExt cx="2097024" cy="2051828"/>
            </a:xfrm>
          </p:grpSpPr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05618" y="1672440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9" name="文本框 8"/>
              <p:cNvSpPr txBox="1"/>
              <p:nvPr/>
            </p:nvSpPr>
            <p:spPr>
              <a:xfrm>
                <a:off x="7200206" y="1303108"/>
                <a:ext cx="19078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6A-Flag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文本框 9"/>
              <p:cNvSpPr txBox="1"/>
              <p:nvPr/>
            </p:nvSpPr>
            <p:spPr>
              <a:xfrm>
                <a:off x="7925420" y="2695904"/>
                <a:ext cx="43030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P</a:t>
                </a:r>
                <a:endParaRPr lang="zh-CN" altLang="en-US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/>
              <p:cNvSpPr txBox="1"/>
              <p:nvPr/>
            </p:nvSpPr>
            <p:spPr>
              <a:xfrm>
                <a:off x="8355724" y="2702629"/>
                <a:ext cx="7750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zh-CN" altLang="en-US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矩形 14"/>
              <p:cNvSpPr/>
              <p:nvPr/>
            </p:nvSpPr>
            <p:spPr>
              <a:xfrm>
                <a:off x="7925420" y="2346761"/>
                <a:ext cx="349624" cy="22137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矩形 15"/>
              <p:cNvSpPr/>
              <p:nvPr/>
            </p:nvSpPr>
            <p:spPr>
              <a:xfrm>
                <a:off x="8293592" y="2346761"/>
                <a:ext cx="349624" cy="22137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组合 21"/>
            <p:cNvGrpSpPr/>
            <p:nvPr/>
          </p:nvGrpSpPr>
          <p:grpSpPr>
            <a:xfrm>
              <a:off x="9594788" y="1302568"/>
              <a:ext cx="2097024" cy="2052368"/>
              <a:chOff x="9594788" y="1302568"/>
              <a:chExt cx="2097024" cy="2052368"/>
            </a:xfrm>
          </p:grpSpPr>
          <p:pic>
            <p:nvPicPr>
              <p:cNvPr id="12" name="图片 11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594788" y="1672440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13" name="文本框 12"/>
              <p:cNvSpPr txBox="1"/>
              <p:nvPr/>
            </p:nvSpPr>
            <p:spPr>
              <a:xfrm>
                <a:off x="9783964" y="1302568"/>
                <a:ext cx="190784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6A-HA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矩形 16"/>
              <p:cNvSpPr/>
              <p:nvPr/>
            </p:nvSpPr>
            <p:spPr>
              <a:xfrm>
                <a:off x="10391020" y="1960642"/>
                <a:ext cx="349624" cy="22137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矩形 17"/>
              <p:cNvSpPr/>
              <p:nvPr/>
            </p:nvSpPr>
            <p:spPr>
              <a:xfrm>
                <a:off x="10765400" y="1960642"/>
                <a:ext cx="349624" cy="221374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10281926" y="2583810"/>
                <a:ext cx="43030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P</a:t>
                </a:r>
                <a:endParaRPr lang="zh-CN" altLang="en-US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10647932" y="2583810"/>
                <a:ext cx="7750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zh-CN" altLang="en-US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5" name="组合 24"/>
            <p:cNvGrpSpPr/>
            <p:nvPr/>
          </p:nvGrpSpPr>
          <p:grpSpPr>
            <a:xfrm>
              <a:off x="8167868" y="3724268"/>
              <a:ext cx="2223152" cy="2052368"/>
              <a:chOff x="9682549" y="3842347"/>
              <a:chExt cx="2223152" cy="2052368"/>
            </a:xfrm>
          </p:grpSpPr>
          <p:grpSp>
            <p:nvGrpSpPr>
              <p:cNvPr id="23" name="组合 22"/>
              <p:cNvGrpSpPr/>
              <p:nvPr/>
            </p:nvGrpSpPr>
            <p:grpSpPr>
              <a:xfrm>
                <a:off x="9682549" y="3842347"/>
                <a:ext cx="2223152" cy="2052368"/>
                <a:chOff x="9682549" y="3842347"/>
                <a:chExt cx="2223152" cy="2052368"/>
              </a:xfrm>
            </p:grpSpPr>
            <p:pic>
              <p:nvPicPr>
                <p:cNvPr id="6" name="图片 5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682549" y="4212219"/>
                  <a:ext cx="2097024" cy="1682496"/>
                </a:xfrm>
                <a:prstGeom prst="rect">
                  <a:avLst/>
                </a:prstGeom>
              </p:spPr>
            </p:pic>
            <p:sp>
              <p:nvSpPr>
                <p:cNvPr id="7" name="文本框 6"/>
                <p:cNvSpPr txBox="1"/>
                <p:nvPr/>
              </p:nvSpPr>
              <p:spPr>
                <a:xfrm>
                  <a:off x="9754435" y="3842347"/>
                  <a:ext cx="215126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igure 6A-GAPDH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矩形 13"/>
                <p:cNvSpPr/>
                <p:nvPr/>
              </p:nvSpPr>
              <p:spPr>
                <a:xfrm>
                  <a:off x="10605247" y="4874482"/>
                  <a:ext cx="349624" cy="221374"/>
                </a:xfrm>
                <a:prstGeom prst="rect">
                  <a:avLst/>
                </a:prstGeom>
                <a:noFill/>
                <a:ln w="28575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" name="文本框 23"/>
              <p:cNvSpPr txBox="1"/>
              <p:nvPr/>
            </p:nvSpPr>
            <p:spPr>
              <a:xfrm>
                <a:off x="10552696" y="5307686"/>
                <a:ext cx="7750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zh-CN" altLang="en-US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" name="组合 1"/>
          <p:cNvGrpSpPr/>
          <p:nvPr/>
        </p:nvGrpSpPr>
        <p:grpSpPr>
          <a:xfrm>
            <a:off x="87495" y="715527"/>
            <a:ext cx="5989590" cy="5984963"/>
            <a:chOff x="87495" y="715527"/>
            <a:chExt cx="5989590" cy="5984963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069" y="820898"/>
              <a:ext cx="5843016" cy="5879592"/>
            </a:xfrm>
            <a:prstGeom prst="rect">
              <a:avLst/>
            </a:prstGeom>
          </p:spPr>
        </p:pic>
        <p:sp>
          <p:nvSpPr>
            <p:cNvPr id="27" name="矩形 26"/>
            <p:cNvSpPr/>
            <p:nvPr/>
          </p:nvSpPr>
          <p:spPr>
            <a:xfrm>
              <a:off x="87495" y="715527"/>
              <a:ext cx="2010246" cy="2230928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04004045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标题 1"/>
          <p:cNvSpPr>
            <a:spLocks noGrp="1"/>
          </p:cNvSpPr>
          <p:nvPr>
            <p:ph type="title"/>
          </p:nvPr>
        </p:nvSpPr>
        <p:spPr>
          <a:xfrm>
            <a:off x="623046" y="58898"/>
            <a:ext cx="3079378" cy="762000"/>
          </a:xfrm>
        </p:spPr>
        <p:txBody>
          <a:bodyPr>
            <a:norm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6-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7" name="组合 56"/>
          <p:cNvGrpSpPr/>
          <p:nvPr/>
        </p:nvGrpSpPr>
        <p:grpSpPr>
          <a:xfrm>
            <a:off x="7149030" y="439898"/>
            <a:ext cx="3970677" cy="6001971"/>
            <a:chOff x="6978701" y="573013"/>
            <a:chExt cx="3970677" cy="6001971"/>
          </a:xfrm>
        </p:grpSpPr>
        <p:grpSp>
          <p:nvGrpSpPr>
            <p:cNvPr id="51" name="组合 50"/>
            <p:cNvGrpSpPr/>
            <p:nvPr/>
          </p:nvGrpSpPr>
          <p:grpSpPr>
            <a:xfrm>
              <a:off x="6978701" y="573013"/>
              <a:ext cx="3859032" cy="2847324"/>
              <a:chOff x="7054314" y="409873"/>
              <a:chExt cx="3859032" cy="2847324"/>
            </a:xfrm>
          </p:grpSpPr>
          <p:grpSp>
            <p:nvGrpSpPr>
              <p:cNvPr id="45" name="组合 44"/>
              <p:cNvGrpSpPr/>
              <p:nvPr/>
            </p:nvGrpSpPr>
            <p:grpSpPr>
              <a:xfrm>
                <a:off x="7054314" y="409873"/>
                <a:ext cx="3859032" cy="2847324"/>
                <a:chOff x="7066905" y="382015"/>
                <a:chExt cx="3859032" cy="2847324"/>
              </a:xfrm>
            </p:grpSpPr>
            <p:sp>
              <p:nvSpPr>
                <p:cNvPr id="34" name="文本框 33"/>
                <p:cNvSpPr txBox="1"/>
                <p:nvPr/>
              </p:nvSpPr>
              <p:spPr>
                <a:xfrm rot="10800000">
                  <a:off x="7066905" y="902453"/>
                  <a:ext cx="461665" cy="1873624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r>
                    <a:rPr lang="en-US" altLang="zh-CN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ithout DTMUV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4" name="组合 43"/>
                <p:cNvGrpSpPr/>
                <p:nvPr/>
              </p:nvGrpSpPr>
              <p:grpSpPr>
                <a:xfrm>
                  <a:off x="7483845" y="382015"/>
                  <a:ext cx="3442092" cy="2847324"/>
                  <a:chOff x="7378794" y="454872"/>
                  <a:chExt cx="3442092" cy="2847324"/>
                </a:xfrm>
              </p:grpSpPr>
              <p:pic>
                <p:nvPicPr>
                  <p:cNvPr id="2" name="图片 1"/>
                  <p:cNvPicPr>
                    <a:picLocks noChangeAspect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468244" y="1931852"/>
                    <a:ext cx="1642282" cy="1370344"/>
                  </a:xfrm>
                  <a:prstGeom prst="rect">
                    <a:avLst/>
                  </a:prstGeom>
                </p:spPr>
              </p:pic>
              <p:pic>
                <p:nvPicPr>
                  <p:cNvPr id="3" name="图片 2"/>
                  <p:cNvPicPr>
                    <a:picLocks noChangeAspect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9178604" y="1915273"/>
                    <a:ext cx="1642282" cy="1370344"/>
                  </a:xfrm>
                  <a:prstGeom prst="rect">
                    <a:avLst/>
                  </a:prstGeom>
                </p:spPr>
              </p:pic>
              <p:pic>
                <p:nvPicPr>
                  <p:cNvPr id="27" name="图片 26"/>
                  <p:cNvPicPr>
                    <a:picLocks noChangeAspect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468246" y="512123"/>
                    <a:ext cx="1642280" cy="1370346"/>
                  </a:xfrm>
                  <a:prstGeom prst="rect">
                    <a:avLst/>
                  </a:prstGeom>
                </p:spPr>
              </p:pic>
              <p:pic>
                <p:nvPicPr>
                  <p:cNvPr id="32" name="图片 31"/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 flipH="1">
                    <a:off x="9179555" y="503673"/>
                    <a:ext cx="1622448" cy="1369830"/>
                  </a:xfrm>
                  <a:prstGeom prst="rect">
                    <a:avLst/>
                  </a:prstGeom>
                </p:spPr>
              </p:pic>
              <p:sp>
                <p:nvSpPr>
                  <p:cNvPr id="36" name="文本框 35"/>
                  <p:cNvSpPr txBox="1"/>
                  <p:nvPr/>
                </p:nvSpPr>
                <p:spPr>
                  <a:xfrm>
                    <a:off x="7387339" y="495648"/>
                    <a:ext cx="822820" cy="2770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 dirty="0" smtClean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API</a:t>
                    </a:r>
                    <a:endParaRPr lang="zh-CN" altLang="en-US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8" name="文本框 37"/>
                  <p:cNvSpPr txBox="1"/>
                  <p:nvPr/>
                </p:nvSpPr>
                <p:spPr>
                  <a:xfrm>
                    <a:off x="7378794" y="1912122"/>
                    <a:ext cx="822820" cy="2770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 dirty="0" smtClean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DX17</a:t>
                    </a:r>
                    <a:endParaRPr lang="zh-CN" altLang="en-US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文本框 38"/>
                  <p:cNvSpPr txBox="1"/>
                  <p:nvPr/>
                </p:nvSpPr>
                <p:spPr>
                  <a:xfrm>
                    <a:off x="9101587" y="1871346"/>
                    <a:ext cx="1519726" cy="2770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 dirty="0" smtClean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rge</a:t>
                    </a:r>
                    <a:endParaRPr lang="zh-CN" altLang="en-US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" name="文本框 36"/>
                  <p:cNvSpPr txBox="1"/>
                  <p:nvPr/>
                </p:nvSpPr>
                <p:spPr>
                  <a:xfrm>
                    <a:off x="9110132" y="454872"/>
                    <a:ext cx="1519726" cy="2770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 dirty="0" smtClean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TMUV C</a:t>
                    </a:r>
                    <a:endParaRPr lang="zh-CN" altLang="en-US" sz="1200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47" name="矩形 46"/>
              <p:cNvSpPr/>
              <p:nvPr/>
            </p:nvSpPr>
            <p:spPr>
              <a:xfrm>
                <a:off x="8014447" y="1922749"/>
                <a:ext cx="1102157" cy="88118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矩形 48"/>
              <p:cNvSpPr/>
              <p:nvPr/>
            </p:nvSpPr>
            <p:spPr>
              <a:xfrm>
                <a:off x="9709993" y="524186"/>
                <a:ext cx="1102157" cy="88118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矩形 47"/>
              <p:cNvSpPr/>
              <p:nvPr/>
            </p:nvSpPr>
            <p:spPr>
              <a:xfrm>
                <a:off x="8031406" y="533349"/>
                <a:ext cx="1102157" cy="88118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矩形 49"/>
              <p:cNvSpPr/>
              <p:nvPr/>
            </p:nvSpPr>
            <p:spPr>
              <a:xfrm>
                <a:off x="9733379" y="1922749"/>
                <a:ext cx="1102157" cy="88118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" name="组合 55"/>
            <p:cNvGrpSpPr/>
            <p:nvPr/>
          </p:nvGrpSpPr>
          <p:grpSpPr>
            <a:xfrm>
              <a:off x="7054315" y="3610488"/>
              <a:ext cx="3895063" cy="2964496"/>
              <a:chOff x="7054315" y="3610488"/>
              <a:chExt cx="3895063" cy="2964496"/>
            </a:xfrm>
          </p:grpSpPr>
          <p:grpSp>
            <p:nvGrpSpPr>
              <p:cNvPr id="46" name="组合 45"/>
              <p:cNvGrpSpPr/>
              <p:nvPr/>
            </p:nvGrpSpPr>
            <p:grpSpPr>
              <a:xfrm>
                <a:off x="7054315" y="3610488"/>
                <a:ext cx="3895063" cy="2964496"/>
                <a:chOff x="7040294" y="3610488"/>
                <a:chExt cx="3895063" cy="2964496"/>
              </a:xfrm>
            </p:grpSpPr>
            <p:pic>
              <p:nvPicPr>
                <p:cNvPr id="28" name="图片 27"/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452389" y="3646372"/>
                  <a:ext cx="1710620" cy="1427368"/>
                </a:xfrm>
                <a:prstGeom prst="rect">
                  <a:avLst/>
                </a:prstGeom>
              </p:spPr>
            </p:pic>
            <p:pic>
              <p:nvPicPr>
                <p:cNvPr id="29" name="图片 28"/>
                <p:cNvPicPr>
                  <a:picLocks noChangeAspect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204891" y="3646372"/>
                  <a:ext cx="1710620" cy="1427368"/>
                </a:xfrm>
                <a:prstGeom prst="rect">
                  <a:avLst/>
                </a:prstGeom>
              </p:spPr>
            </p:pic>
            <p:pic>
              <p:nvPicPr>
                <p:cNvPr id="30" name="图片 29"/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185046" y="5114494"/>
                  <a:ext cx="1750311" cy="1460490"/>
                </a:xfrm>
                <a:prstGeom prst="rect">
                  <a:avLst/>
                </a:prstGeom>
              </p:spPr>
            </p:pic>
            <p:pic>
              <p:nvPicPr>
                <p:cNvPr id="31" name="图片 30"/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452391" y="5123459"/>
                  <a:ext cx="1710618" cy="1427368"/>
                </a:xfrm>
                <a:prstGeom prst="rect">
                  <a:avLst/>
                </a:prstGeom>
              </p:spPr>
            </p:pic>
            <p:sp>
              <p:nvSpPr>
                <p:cNvPr id="35" name="文本框 34"/>
                <p:cNvSpPr txBox="1"/>
                <p:nvPr/>
              </p:nvSpPr>
              <p:spPr>
                <a:xfrm rot="10800000">
                  <a:off x="7040294" y="4204447"/>
                  <a:ext cx="461665" cy="1564728"/>
                </a:xfrm>
                <a:prstGeom prst="rect">
                  <a:avLst/>
                </a:prstGeom>
                <a:noFill/>
              </p:spPr>
              <p:txBody>
                <a:bodyPr vert="eaVert" wrap="square" rtlCol="0">
                  <a:spAutoFit/>
                </a:bodyPr>
                <a:lstStyle/>
                <a:p>
                  <a:r>
                    <a:rPr lang="en-US" altLang="zh-CN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ith DTMUV</a:t>
                  </a:r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文本框 39"/>
                <p:cNvSpPr txBox="1"/>
                <p:nvPr/>
              </p:nvSpPr>
              <p:spPr>
                <a:xfrm>
                  <a:off x="7447364" y="3651264"/>
                  <a:ext cx="74407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  <a:endParaRPr lang="zh-CN" alt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文本框 40"/>
                <p:cNvSpPr txBox="1"/>
                <p:nvPr/>
              </p:nvSpPr>
              <p:spPr>
                <a:xfrm>
                  <a:off x="9122820" y="3610488"/>
                  <a:ext cx="13742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TMUV C</a:t>
                  </a:r>
                  <a:endParaRPr lang="zh-CN" alt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文本框 41"/>
                <p:cNvSpPr txBox="1"/>
                <p:nvPr/>
              </p:nvSpPr>
              <p:spPr>
                <a:xfrm>
                  <a:off x="7427128" y="5109624"/>
                  <a:ext cx="74407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DX17</a:t>
                  </a:r>
                  <a:endParaRPr lang="zh-CN" alt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" name="文本框 42"/>
                <p:cNvSpPr txBox="1"/>
                <p:nvPr/>
              </p:nvSpPr>
              <p:spPr>
                <a:xfrm>
                  <a:off x="9102584" y="5068848"/>
                  <a:ext cx="13742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 smtClean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erge</a:t>
                  </a:r>
                  <a:endParaRPr lang="zh-CN" altLang="en-US" sz="12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2" name="矩形 51"/>
              <p:cNvSpPr/>
              <p:nvPr/>
            </p:nvSpPr>
            <p:spPr>
              <a:xfrm>
                <a:off x="9914965" y="5119386"/>
                <a:ext cx="722997" cy="64979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矩形 52"/>
              <p:cNvSpPr/>
              <p:nvPr/>
            </p:nvSpPr>
            <p:spPr>
              <a:xfrm>
                <a:off x="9922958" y="3660401"/>
                <a:ext cx="722997" cy="64979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矩形 53"/>
              <p:cNvSpPr/>
              <p:nvPr/>
            </p:nvSpPr>
            <p:spPr>
              <a:xfrm>
                <a:off x="8188847" y="3656394"/>
                <a:ext cx="722997" cy="64979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矩形 54"/>
              <p:cNvSpPr/>
              <p:nvPr/>
            </p:nvSpPr>
            <p:spPr>
              <a:xfrm>
                <a:off x="8185220" y="5138020"/>
                <a:ext cx="722997" cy="649790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" name="组合 5"/>
          <p:cNvGrpSpPr/>
          <p:nvPr/>
        </p:nvGrpSpPr>
        <p:grpSpPr>
          <a:xfrm>
            <a:off x="234069" y="716898"/>
            <a:ext cx="6014988" cy="5983592"/>
            <a:chOff x="234069" y="716898"/>
            <a:chExt cx="6014988" cy="5983592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4069" y="820898"/>
              <a:ext cx="5843016" cy="5879592"/>
            </a:xfrm>
            <a:prstGeom prst="rect">
              <a:avLst/>
            </a:prstGeom>
          </p:spPr>
        </p:pic>
        <p:sp>
          <p:nvSpPr>
            <p:cNvPr id="58" name="矩形 57"/>
            <p:cNvSpPr/>
            <p:nvPr/>
          </p:nvSpPr>
          <p:spPr>
            <a:xfrm>
              <a:off x="2162003" y="716898"/>
              <a:ext cx="4087054" cy="2214561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410152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标题 1"/>
          <p:cNvSpPr>
            <a:spLocks noGrp="1"/>
          </p:cNvSpPr>
          <p:nvPr>
            <p:ph type="title"/>
          </p:nvPr>
        </p:nvSpPr>
        <p:spPr>
          <a:xfrm>
            <a:off x="623045" y="58898"/>
            <a:ext cx="2765613" cy="762000"/>
          </a:xfrm>
        </p:spPr>
        <p:txBody>
          <a:bodyPr>
            <a:normAutofit fontScale="90000"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6-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5" name="组合 44"/>
          <p:cNvGrpSpPr/>
          <p:nvPr/>
        </p:nvGrpSpPr>
        <p:grpSpPr>
          <a:xfrm>
            <a:off x="5973859" y="1323728"/>
            <a:ext cx="6012014" cy="4122330"/>
            <a:chOff x="6045577" y="1296834"/>
            <a:chExt cx="6012014" cy="4122330"/>
          </a:xfrm>
        </p:grpSpPr>
        <p:grpSp>
          <p:nvGrpSpPr>
            <p:cNvPr id="40" name="组合 39"/>
            <p:cNvGrpSpPr/>
            <p:nvPr/>
          </p:nvGrpSpPr>
          <p:grpSpPr>
            <a:xfrm>
              <a:off x="6941120" y="1296834"/>
              <a:ext cx="2137073" cy="1682496"/>
              <a:chOff x="6941120" y="1296834"/>
              <a:chExt cx="2137073" cy="1682496"/>
            </a:xfrm>
          </p:grpSpPr>
          <p:pic>
            <p:nvPicPr>
              <p:cNvPr id="29" name="图片 28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41120" y="1296834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30" name="矩形 29"/>
              <p:cNvSpPr/>
              <p:nvPr/>
            </p:nvSpPr>
            <p:spPr>
              <a:xfrm>
                <a:off x="7458634" y="2046429"/>
                <a:ext cx="1340987" cy="29770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>
                <a:off x="7006258" y="1612993"/>
                <a:ext cx="207193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6D-IP</a:t>
                </a:r>
                <a:r>
                  <a:rPr lang="zh-CN" alt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A</a:t>
                </a:r>
                <a:r>
                  <a:rPr lang="zh-CN" alt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）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1" name="组合 40"/>
            <p:cNvGrpSpPr/>
            <p:nvPr/>
          </p:nvGrpSpPr>
          <p:grpSpPr>
            <a:xfrm>
              <a:off x="9118243" y="1503022"/>
              <a:ext cx="2383475" cy="1682496"/>
              <a:chOff x="9118243" y="1503022"/>
              <a:chExt cx="2383475" cy="1682496"/>
            </a:xfrm>
          </p:grpSpPr>
          <p:pic>
            <p:nvPicPr>
              <p:cNvPr id="28" name="图片 27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118243" y="1503022"/>
                <a:ext cx="2097024" cy="1682496"/>
              </a:xfrm>
              <a:prstGeom prst="rect">
                <a:avLst/>
              </a:prstGeom>
            </p:spPr>
          </p:pic>
          <p:sp>
            <p:nvSpPr>
              <p:cNvPr id="32" name="矩形 31"/>
              <p:cNvSpPr/>
              <p:nvPr/>
            </p:nvSpPr>
            <p:spPr>
              <a:xfrm>
                <a:off x="9681881" y="2138081"/>
                <a:ext cx="1340987" cy="694765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9183382" y="1653401"/>
                <a:ext cx="231833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6D-IP</a:t>
                </a:r>
                <a:r>
                  <a:rPr lang="zh-CN" alt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lag</a:t>
                </a:r>
                <a:r>
                  <a:rPr lang="zh-CN" alt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）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3" name="组合 42"/>
            <p:cNvGrpSpPr/>
            <p:nvPr/>
          </p:nvGrpSpPr>
          <p:grpSpPr>
            <a:xfrm>
              <a:off x="8390185" y="3588169"/>
              <a:ext cx="1926372" cy="1817548"/>
              <a:chOff x="8390185" y="3588169"/>
              <a:chExt cx="1926372" cy="1817548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90185" y="3980329"/>
                <a:ext cx="1776570" cy="1425388"/>
              </a:xfrm>
              <a:prstGeom prst="rect">
                <a:avLst/>
              </a:prstGeom>
            </p:spPr>
          </p:pic>
          <p:sp>
            <p:nvSpPr>
              <p:cNvPr id="34" name="矩形 33"/>
              <p:cNvSpPr/>
              <p:nvPr/>
            </p:nvSpPr>
            <p:spPr>
              <a:xfrm>
                <a:off x="8677834" y="4477870"/>
                <a:ext cx="1340987" cy="694765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8610987" y="3588169"/>
                <a:ext cx="1705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r>
                  <a:rPr lang="zh-CN" alt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lag</a:t>
                </a:r>
                <a:r>
                  <a:rPr lang="zh-CN" alt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）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" name="组合 41"/>
            <p:cNvGrpSpPr/>
            <p:nvPr/>
          </p:nvGrpSpPr>
          <p:grpSpPr>
            <a:xfrm>
              <a:off x="6045577" y="3588169"/>
              <a:ext cx="2565410" cy="1817548"/>
              <a:chOff x="6045577" y="3588169"/>
              <a:chExt cx="2565410" cy="1817548"/>
            </a:xfrm>
          </p:grpSpPr>
          <p:pic>
            <p:nvPicPr>
              <p:cNvPr id="2" name="图片 1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99349" y="3980329"/>
                <a:ext cx="1776570" cy="1425388"/>
              </a:xfrm>
              <a:prstGeom prst="rect">
                <a:avLst/>
              </a:prstGeom>
            </p:spPr>
          </p:pic>
          <p:sp>
            <p:nvSpPr>
              <p:cNvPr id="33" name="矩形 32"/>
              <p:cNvSpPr/>
              <p:nvPr/>
            </p:nvSpPr>
            <p:spPr>
              <a:xfrm>
                <a:off x="6788140" y="4395317"/>
                <a:ext cx="1340987" cy="29770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/>
              <p:cNvSpPr txBox="1"/>
              <p:nvPr/>
            </p:nvSpPr>
            <p:spPr>
              <a:xfrm>
                <a:off x="6045577" y="3588169"/>
                <a:ext cx="256541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igure 6D-Input</a:t>
                </a:r>
                <a:r>
                  <a:rPr lang="zh-CN" alt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A</a:t>
                </a:r>
                <a:r>
                  <a:rPr lang="zh-CN" alt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）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4" name="组合 43"/>
            <p:cNvGrpSpPr/>
            <p:nvPr/>
          </p:nvGrpSpPr>
          <p:grpSpPr>
            <a:xfrm>
              <a:off x="10281021" y="3617350"/>
              <a:ext cx="1776570" cy="1801814"/>
              <a:chOff x="10281021" y="3617350"/>
              <a:chExt cx="1776570" cy="1801814"/>
            </a:xfrm>
          </p:grpSpPr>
          <p:pic>
            <p:nvPicPr>
              <p:cNvPr id="27" name="图片 26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281021" y="3993776"/>
                <a:ext cx="1776570" cy="1425388"/>
              </a:xfrm>
              <a:prstGeom prst="rect">
                <a:avLst/>
              </a:prstGeom>
            </p:spPr>
          </p:pic>
          <p:sp>
            <p:nvSpPr>
              <p:cNvPr id="35" name="矩形 34"/>
              <p:cNvSpPr/>
              <p:nvPr/>
            </p:nvSpPr>
            <p:spPr>
              <a:xfrm>
                <a:off x="10544773" y="4676399"/>
                <a:ext cx="1340987" cy="29770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10316557" y="3617350"/>
                <a:ext cx="174103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r>
                  <a:rPr lang="zh-CN" alt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r>
                  <a:rPr lang="zh-CN" alt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）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" name="组合 5"/>
          <p:cNvGrpSpPr/>
          <p:nvPr/>
        </p:nvGrpSpPr>
        <p:grpSpPr>
          <a:xfrm>
            <a:off x="99599" y="1039906"/>
            <a:ext cx="5678743" cy="5633690"/>
            <a:chOff x="99599" y="1039906"/>
            <a:chExt cx="5678743" cy="5633690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9599" y="1039906"/>
              <a:ext cx="5598644" cy="5633690"/>
            </a:xfrm>
            <a:prstGeom prst="rect">
              <a:avLst/>
            </a:prstGeom>
          </p:spPr>
        </p:pic>
        <p:sp>
          <p:nvSpPr>
            <p:cNvPr id="25" name="矩形 24"/>
            <p:cNvSpPr/>
            <p:nvPr/>
          </p:nvSpPr>
          <p:spPr>
            <a:xfrm>
              <a:off x="3533604" y="3001671"/>
              <a:ext cx="2244738" cy="259230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3140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8</TotalTime>
  <Words>124</Words>
  <Application>Microsoft Office PowerPoint</Application>
  <PresentationFormat>宽屏</PresentationFormat>
  <Paragraphs>57</Paragraphs>
  <Slides>8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Full uncropped Gels and Blots image(s)</vt:lpstr>
      <vt:lpstr>Figure 3</vt:lpstr>
      <vt:lpstr>Figure 4-B, D</vt:lpstr>
      <vt:lpstr>Figure 4-F, H</vt:lpstr>
      <vt:lpstr>Figure 5</vt:lpstr>
      <vt:lpstr>Figure 6-A</vt:lpstr>
      <vt:lpstr>Figure 6-B</vt:lpstr>
      <vt:lpstr>Figure 6-D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ull uncropped Gels and Blots image(s)</dc:title>
  <dc:creator>China</dc:creator>
  <cp:lastModifiedBy>China</cp:lastModifiedBy>
  <cp:revision>54</cp:revision>
  <dcterms:created xsi:type="dcterms:W3CDTF">2025-07-08T08:49:08Z</dcterms:created>
  <dcterms:modified xsi:type="dcterms:W3CDTF">2025-07-10T14:15:22Z</dcterms:modified>
</cp:coreProperties>
</file>